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534"/>
  </p:normalViewPr>
  <p:slideViewPr>
    <p:cSldViewPr snapToGrid="0" snapToObjects="1">
      <p:cViewPr varScale="1">
        <p:scale>
          <a:sx n="79" d="100"/>
          <a:sy n="79" d="100"/>
        </p:scale>
        <p:origin x="9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aekikiyoshi/Desktop/&#30452;&#33144;&#22730;&#27515;&#30151;&#20363;/submission/supplementary%20grap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  <a:r>
              <a:rPr lang="en-US" altLang="ja-JP" sz="1800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est</a:t>
            </a:r>
            <a:r>
              <a:rPr lang="en-US" altLang="ja-JP" sz="1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a in chronological</a:t>
            </a:r>
            <a:r>
              <a:rPr lang="en-US" altLang="ja-JP" sz="1800" baseline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der</a:t>
            </a:r>
            <a:r>
              <a:rPr lang="ja-JP" altLang="en-US" sz="1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0961972919272941"/>
          <c:y val="0.10411280424479315"/>
          <c:w val="0.86467933622783133"/>
          <c:h val="0.61903224500536402"/>
        </c:manualLayout>
      </c:layout>
      <c:lineChart>
        <c:grouping val="standar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WBC (x10^2/μL)</c:v>
                </c:pt>
              </c:strCache>
            </c:strRef>
          </c:tx>
          <c:spPr>
            <a:ln w="28575" cap="rnd">
              <a:solidFill>
                <a:srgbClr val="0432FF"/>
              </a:solidFill>
              <a:round/>
            </a:ln>
            <a:effectLst/>
          </c:spPr>
          <c:marker>
            <c:symbol val="none"/>
          </c:marker>
          <c:cat>
            <c:strRef>
              <c:f>Sheet1!$B$1:$S$1</c:f>
              <c:strCache>
                <c:ptCount val="18"/>
                <c:pt idx="0">
                  <c:v>day -2</c:v>
                </c:pt>
                <c:pt idx="1">
                  <c:v>day 4</c:v>
                </c:pt>
                <c:pt idx="2">
                  <c:v>day 35</c:v>
                </c:pt>
                <c:pt idx="3">
                  <c:v>day 56</c:v>
                </c:pt>
                <c:pt idx="4">
                  <c:v>day 58</c:v>
                </c:pt>
                <c:pt idx="5">
                  <c:v>day 62</c:v>
                </c:pt>
                <c:pt idx="6">
                  <c:v>day 64</c:v>
                </c:pt>
                <c:pt idx="7">
                  <c:v>day 77</c:v>
                </c:pt>
                <c:pt idx="8">
                  <c:v>day78</c:v>
                </c:pt>
                <c:pt idx="9">
                  <c:v>day 85</c:v>
                </c:pt>
                <c:pt idx="10">
                  <c:v>day 138</c:v>
                </c:pt>
                <c:pt idx="11">
                  <c:v>day 168</c:v>
                </c:pt>
                <c:pt idx="12">
                  <c:v>day 217</c:v>
                </c:pt>
                <c:pt idx="13">
                  <c:v>day 225</c:v>
                </c:pt>
                <c:pt idx="14">
                  <c:v>day 231</c:v>
                </c:pt>
                <c:pt idx="15">
                  <c:v>day238</c:v>
                </c:pt>
                <c:pt idx="16">
                  <c:v>day 245</c:v>
                </c:pt>
                <c:pt idx="17">
                  <c:v>day 267</c:v>
                </c:pt>
              </c:strCache>
            </c:strRef>
          </c:cat>
          <c:val>
            <c:numRef>
              <c:f>Sheet1!$B$2:$S$2</c:f>
              <c:numCache>
                <c:formatCode>General</c:formatCode>
                <c:ptCount val="18"/>
                <c:pt idx="0">
                  <c:v>49.6</c:v>
                </c:pt>
                <c:pt idx="1">
                  <c:v>4.0999999999999996</c:v>
                </c:pt>
                <c:pt idx="2">
                  <c:v>18.100000000000001</c:v>
                </c:pt>
                <c:pt idx="3">
                  <c:v>1</c:v>
                </c:pt>
                <c:pt idx="4">
                  <c:v>1</c:v>
                </c:pt>
                <c:pt idx="5">
                  <c:v>14</c:v>
                </c:pt>
                <c:pt idx="6">
                  <c:v>28</c:v>
                </c:pt>
                <c:pt idx="7">
                  <c:v>36</c:v>
                </c:pt>
                <c:pt idx="8">
                  <c:v>38</c:v>
                </c:pt>
                <c:pt idx="9">
                  <c:v>44</c:v>
                </c:pt>
                <c:pt idx="10">
                  <c:v>12</c:v>
                </c:pt>
                <c:pt idx="11">
                  <c:v>74</c:v>
                </c:pt>
                <c:pt idx="12">
                  <c:v>25</c:v>
                </c:pt>
                <c:pt idx="13">
                  <c:v>46</c:v>
                </c:pt>
                <c:pt idx="14">
                  <c:v>51</c:v>
                </c:pt>
                <c:pt idx="15">
                  <c:v>40</c:v>
                </c:pt>
                <c:pt idx="16">
                  <c:v>13</c:v>
                </c:pt>
                <c:pt idx="17">
                  <c:v>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4DB-4240-BF56-17EA7CDC1235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CRP (mg/dL)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Sheet1!$B$1:$S$1</c:f>
              <c:strCache>
                <c:ptCount val="18"/>
                <c:pt idx="0">
                  <c:v>day -2</c:v>
                </c:pt>
                <c:pt idx="1">
                  <c:v>day 4</c:v>
                </c:pt>
                <c:pt idx="2">
                  <c:v>day 35</c:v>
                </c:pt>
                <c:pt idx="3">
                  <c:v>day 56</c:v>
                </c:pt>
                <c:pt idx="4">
                  <c:v>day 58</c:v>
                </c:pt>
                <c:pt idx="5">
                  <c:v>day 62</c:v>
                </c:pt>
                <c:pt idx="6">
                  <c:v>day 64</c:v>
                </c:pt>
                <c:pt idx="7">
                  <c:v>day 77</c:v>
                </c:pt>
                <c:pt idx="8">
                  <c:v>day78</c:v>
                </c:pt>
                <c:pt idx="9">
                  <c:v>day 85</c:v>
                </c:pt>
                <c:pt idx="10">
                  <c:v>day 138</c:v>
                </c:pt>
                <c:pt idx="11">
                  <c:v>day 168</c:v>
                </c:pt>
                <c:pt idx="12">
                  <c:v>day 217</c:v>
                </c:pt>
                <c:pt idx="13">
                  <c:v>day 225</c:v>
                </c:pt>
                <c:pt idx="14">
                  <c:v>day 231</c:v>
                </c:pt>
                <c:pt idx="15">
                  <c:v>day238</c:v>
                </c:pt>
                <c:pt idx="16">
                  <c:v>day 245</c:v>
                </c:pt>
                <c:pt idx="17">
                  <c:v>day 267</c:v>
                </c:pt>
              </c:strCache>
            </c:strRef>
          </c:cat>
          <c:val>
            <c:numRef>
              <c:f>Sheet1!$B$3:$S$3</c:f>
              <c:numCache>
                <c:formatCode>General</c:formatCode>
                <c:ptCount val="18"/>
                <c:pt idx="0">
                  <c:v>0.73</c:v>
                </c:pt>
                <c:pt idx="1">
                  <c:v>17.57</c:v>
                </c:pt>
                <c:pt idx="2">
                  <c:v>0.01</c:v>
                </c:pt>
                <c:pt idx="3">
                  <c:v>4.0199999999999996</c:v>
                </c:pt>
                <c:pt idx="4">
                  <c:v>11.57</c:v>
                </c:pt>
                <c:pt idx="5">
                  <c:v>9.9</c:v>
                </c:pt>
                <c:pt idx="6">
                  <c:v>6.33</c:v>
                </c:pt>
                <c:pt idx="7">
                  <c:v>2.37</c:v>
                </c:pt>
                <c:pt idx="8">
                  <c:v>6.07</c:v>
                </c:pt>
                <c:pt idx="9">
                  <c:v>1.08</c:v>
                </c:pt>
                <c:pt idx="10">
                  <c:v>13.18</c:v>
                </c:pt>
                <c:pt idx="11">
                  <c:v>0.71</c:v>
                </c:pt>
                <c:pt idx="12">
                  <c:v>1.3</c:v>
                </c:pt>
                <c:pt idx="13">
                  <c:v>7.15</c:v>
                </c:pt>
                <c:pt idx="14">
                  <c:v>2.54</c:v>
                </c:pt>
                <c:pt idx="15">
                  <c:v>5.91</c:v>
                </c:pt>
                <c:pt idx="16">
                  <c:v>1.54</c:v>
                </c:pt>
                <c:pt idx="17">
                  <c:v>1.12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4DB-4240-BF56-17EA7CDC1235}"/>
            </c:ext>
          </c:extLst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FDP (μg/mL)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cat>
            <c:strRef>
              <c:f>Sheet1!$B$1:$S$1</c:f>
              <c:strCache>
                <c:ptCount val="18"/>
                <c:pt idx="0">
                  <c:v>day -2</c:v>
                </c:pt>
                <c:pt idx="1">
                  <c:v>day 4</c:v>
                </c:pt>
                <c:pt idx="2">
                  <c:v>day 35</c:v>
                </c:pt>
                <c:pt idx="3">
                  <c:v>day 56</c:v>
                </c:pt>
                <c:pt idx="4">
                  <c:v>day 58</c:v>
                </c:pt>
                <c:pt idx="5">
                  <c:v>day 62</c:v>
                </c:pt>
                <c:pt idx="6">
                  <c:v>day 64</c:v>
                </c:pt>
                <c:pt idx="7">
                  <c:v>day 77</c:v>
                </c:pt>
                <c:pt idx="8">
                  <c:v>day78</c:v>
                </c:pt>
                <c:pt idx="9">
                  <c:v>day 85</c:v>
                </c:pt>
                <c:pt idx="10">
                  <c:v>day 138</c:v>
                </c:pt>
                <c:pt idx="11">
                  <c:v>day 168</c:v>
                </c:pt>
                <c:pt idx="12">
                  <c:v>day 217</c:v>
                </c:pt>
                <c:pt idx="13">
                  <c:v>day 225</c:v>
                </c:pt>
                <c:pt idx="14">
                  <c:v>day 231</c:v>
                </c:pt>
                <c:pt idx="15">
                  <c:v>day238</c:v>
                </c:pt>
                <c:pt idx="16">
                  <c:v>day 245</c:v>
                </c:pt>
                <c:pt idx="17">
                  <c:v>day 267</c:v>
                </c:pt>
              </c:strCache>
            </c:strRef>
          </c:cat>
          <c:val>
            <c:numRef>
              <c:f>Sheet1!$B$4:$S$4</c:f>
              <c:numCache>
                <c:formatCode>General</c:formatCode>
                <c:ptCount val="18"/>
                <c:pt idx="0">
                  <c:v>2.5</c:v>
                </c:pt>
                <c:pt idx="1">
                  <c:v>4.5</c:v>
                </c:pt>
                <c:pt idx="2">
                  <c:v>2.5</c:v>
                </c:pt>
                <c:pt idx="3">
                  <c:v>0</c:v>
                </c:pt>
                <c:pt idx="4">
                  <c:v>3.6</c:v>
                </c:pt>
                <c:pt idx="5">
                  <c:v>7.8</c:v>
                </c:pt>
                <c:pt idx="6">
                  <c:v>8.9</c:v>
                </c:pt>
                <c:pt idx="7">
                  <c:v>0</c:v>
                </c:pt>
                <c:pt idx="8">
                  <c:v>2.9</c:v>
                </c:pt>
                <c:pt idx="9">
                  <c:v>4.4000000000000004</c:v>
                </c:pt>
                <c:pt idx="10">
                  <c:v>3.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4DB-4240-BF56-17EA7CDC1235}"/>
            </c:ext>
          </c:extLst>
        </c:ser>
        <c:ser>
          <c:idx val="3"/>
          <c:order val="3"/>
          <c:tx>
            <c:strRef>
              <c:f>Sheet1!$A$5</c:f>
              <c:strCache>
                <c:ptCount val="1"/>
                <c:pt idx="0">
                  <c:v>D-dimer (μg/mL)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Sheet1!$B$1:$S$1</c:f>
              <c:strCache>
                <c:ptCount val="18"/>
                <c:pt idx="0">
                  <c:v>day -2</c:v>
                </c:pt>
                <c:pt idx="1">
                  <c:v>day 4</c:v>
                </c:pt>
                <c:pt idx="2">
                  <c:v>day 35</c:v>
                </c:pt>
                <c:pt idx="3">
                  <c:v>day 56</c:v>
                </c:pt>
                <c:pt idx="4">
                  <c:v>day 58</c:v>
                </c:pt>
                <c:pt idx="5">
                  <c:v>day 62</c:v>
                </c:pt>
                <c:pt idx="6">
                  <c:v>day 64</c:v>
                </c:pt>
                <c:pt idx="7">
                  <c:v>day 77</c:v>
                </c:pt>
                <c:pt idx="8">
                  <c:v>day78</c:v>
                </c:pt>
                <c:pt idx="9">
                  <c:v>day 85</c:v>
                </c:pt>
                <c:pt idx="10">
                  <c:v>day 138</c:v>
                </c:pt>
                <c:pt idx="11">
                  <c:v>day 168</c:v>
                </c:pt>
                <c:pt idx="12">
                  <c:v>day 217</c:v>
                </c:pt>
                <c:pt idx="13">
                  <c:v>day 225</c:v>
                </c:pt>
                <c:pt idx="14">
                  <c:v>day 231</c:v>
                </c:pt>
                <c:pt idx="15">
                  <c:v>day238</c:v>
                </c:pt>
                <c:pt idx="16">
                  <c:v>day 245</c:v>
                </c:pt>
                <c:pt idx="17">
                  <c:v>day 267</c:v>
                </c:pt>
              </c:strCache>
            </c:strRef>
          </c:cat>
          <c:val>
            <c:numRef>
              <c:f>Sheet1!$B$5:$S$5</c:f>
              <c:numCache>
                <c:formatCode>General</c:formatCode>
                <c:ptCount val="1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100000000000000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.8</c:v>
                </c:pt>
                <c:pt idx="12">
                  <c:v>0.1</c:v>
                </c:pt>
                <c:pt idx="13">
                  <c:v>1.1000000000000001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4DB-4240-BF56-17EA7CDC12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841086687"/>
        <c:axId val="804282495"/>
      </c:lineChart>
      <c:catAx>
        <c:axId val="841086687"/>
        <c:scaling>
          <c:orientation val="minMax"/>
        </c:scaling>
        <c:delete val="0"/>
        <c:axPos val="b"/>
        <c:numFmt formatCode="General" sourceLinked="1"/>
        <c:majorTickMark val="none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04282495"/>
        <c:crosses val="autoZero"/>
        <c:auto val="1"/>
        <c:lblAlgn val="ctr"/>
        <c:lblOffset val="100"/>
        <c:noMultiLvlLbl val="0"/>
      </c:catAx>
      <c:valAx>
        <c:axId val="80428249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4108668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9.1355140186915873E-2"/>
          <c:y val="0.88937797299759125"/>
          <c:w val="0.78457943925233642"/>
          <c:h val="9.519786247798717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63422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341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5651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2953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78004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2242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2948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775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5829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96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578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93532-108E-074F-ABF7-E11C651974D7}" type="datetimeFigureOut">
              <a:rPr kumimoji="1" lang="ja-JP" altLang="en-US" smtClean="0"/>
              <a:t>2024/7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CE26F-A0CD-6F4C-89C2-725B3FF19EF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69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24A9882-C96F-1C47-8EF4-029F82BCC524}"/>
              </a:ext>
            </a:extLst>
          </p:cNvPr>
          <p:cNvSpPr txBox="1"/>
          <p:nvPr/>
        </p:nvSpPr>
        <p:spPr>
          <a:xfrm>
            <a:off x="130629" y="179614"/>
            <a:ext cx="2764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4297587B-738D-A840-991B-52CD4F50BA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1237614"/>
              </p:ext>
            </p:extLst>
          </p:nvPr>
        </p:nvGraphicFramePr>
        <p:xfrm>
          <a:off x="762000" y="897890"/>
          <a:ext cx="7223760" cy="4940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A83F77-0CED-0F44-9283-A9CD54C5ABCA}"/>
              </a:ext>
            </a:extLst>
          </p:cNvPr>
          <p:cNvSpPr txBox="1"/>
          <p:nvPr/>
        </p:nvSpPr>
        <p:spPr>
          <a:xfrm>
            <a:off x="1036320" y="5839460"/>
            <a:ext cx="3337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y 0: CAR-T therapy day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4274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15</Words>
  <Application>Microsoft Macintosh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伯潔</dc:creator>
  <cp:lastModifiedBy>佐伯潔</cp:lastModifiedBy>
  <cp:revision>5</cp:revision>
  <dcterms:created xsi:type="dcterms:W3CDTF">2024-07-31T04:47:01Z</dcterms:created>
  <dcterms:modified xsi:type="dcterms:W3CDTF">2024-07-31T06:59:25Z</dcterms:modified>
</cp:coreProperties>
</file>